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theme/theme1.xml" ContentType="application/vnd.openxmlformats-officedocument.theme+xml"/>
  <Override PartName="/ppt/notesMasters/notesMaster1.xml" ContentType="application/vnd.openxmlformats-officedocument.presentationml.notesMaster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ppt/presProps.xml" ContentType="application/vnd.openxmlformats-officedocument.presentationml.presProps+xml"/>
  <Override PartName="/docProps/custom.xml" ContentType="application/vnd.openxmlformats-officedocument.custom-properties+xml"/>
  <Override PartName="/docProps/app.xml" ContentType="application/vnd.openxmlformats-officedocument.extended-properties+xml"/>
  <Override PartName="/docProps/core.xml" ContentType="application/vnd.openxmlformats-package.core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4" r:id="rId2"/>
    <p:sldId id="262" r:id="rId3"/>
    <p:sldId id="265" r:id="rId4"/>
    <p:sldId id="266" r:id="rId5"/>
    <p:sldId id="267" r:id="rId6"/>
  </p:sldIdLst>
  <p:sldSz cx="12192000" cy="6858000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834"/>
    <p:restoredTop sz="94719"/>
  </p:normalViewPr>
  <p:slideViewPr>
    <p:cSldViewPr>
      <p:cViewPr varScale="1">
        <p:scale>
          <a:sx n="144" d="100"/>
          <a:sy n="144" d="100"/>
        </p:scale>
        <p:origin x="1640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openxmlformats.org/officeDocument/2006/relationships/customXml" Target="../customXml/item2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Relationship Id="rId14" Type="http://schemas.openxmlformats.org/officeDocument/2006/relationships/customXml" Target="../customXml/item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>
            <a:extLst>
              <a:ext uri="{FF2B5EF4-FFF2-40B4-BE49-F238E27FC236}">
                <a16:creationId xmlns:a16="http://schemas.microsoft.com/office/drawing/2014/main" id="{A2DB3BCC-458C-440E-F0B3-3E3735DD2B0C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89B8161-F0F6-B1AA-BA99-A8E87BE01B4C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smtClean="0"/>
            </a:lvl1pPr>
          </a:lstStyle>
          <a:p>
            <a:pPr>
              <a:defRPr/>
            </a:pPr>
            <a:fld id="{0A577623-7D36-E741-AA65-1EE729912DBB}" type="datetimeFigureOut">
              <a:rPr lang="zh-CN" altLang="en-US"/>
              <a:pPr>
                <a:defRPr/>
              </a:pPr>
              <a:t>2025/7/21</a:t>
            </a:fld>
            <a:endParaRPr lang="zh-CN" altLang="en-US"/>
          </a:p>
        </p:txBody>
      </p:sp>
      <p:sp>
        <p:nvSpPr>
          <p:cNvPr id="4" name="幻灯片图像占位符 3">
            <a:extLst>
              <a:ext uri="{FF2B5EF4-FFF2-40B4-BE49-F238E27FC236}">
                <a16:creationId xmlns:a16="http://schemas.microsoft.com/office/drawing/2014/main" id="{1068C657-082D-8CCA-EF53-4CB90BBB1171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>
            <a:extLst>
              <a:ext uri="{FF2B5EF4-FFF2-40B4-BE49-F238E27FC236}">
                <a16:creationId xmlns:a16="http://schemas.microsoft.com/office/drawing/2014/main" id="{34114404-4D24-8971-C8D8-912D946047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E360070-1299-46AC-734A-BE1463AC33BC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78833A0-3358-BBB7-5F75-CC0EA87C5C0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 smtClean="0"/>
            </a:lvl1pPr>
          </a:lstStyle>
          <a:p>
            <a:pPr>
              <a:defRPr/>
            </a:pPr>
            <a:fld id="{8018C8EF-2434-C546-B1F8-9590C8DE0D1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幻灯片图像占位符 1">
            <a:extLst>
              <a:ext uri="{FF2B5EF4-FFF2-40B4-BE49-F238E27FC236}">
                <a16:creationId xmlns:a16="http://schemas.microsoft.com/office/drawing/2014/main" id="{C9575EDD-E57E-E5B1-EB3B-EEBE680E1111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123" name="备注占位符 2">
            <a:extLst>
              <a:ext uri="{FF2B5EF4-FFF2-40B4-BE49-F238E27FC236}">
                <a16:creationId xmlns:a16="http://schemas.microsoft.com/office/drawing/2014/main" id="{7E75343D-F746-C766-8E1E-DDD6A456466C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spcBef>
                <a:spcPct val="0"/>
              </a:spcBef>
            </a:pPr>
            <a:endParaRPr lang="zh-CN" altLang="en-US"/>
          </a:p>
        </p:txBody>
      </p:sp>
      <p:sp>
        <p:nvSpPr>
          <p:cNvPr id="5124" name="灯片编号占位符 3">
            <a:extLst>
              <a:ext uri="{FF2B5EF4-FFF2-40B4-BE49-F238E27FC236}">
                <a16:creationId xmlns:a16="http://schemas.microsoft.com/office/drawing/2014/main" id="{61CE8BD4-34BC-B3B1-C4A6-7D34ED82E3C8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B69FA7BF-3294-1C45-9515-F91B5683CB87}" type="slidenum">
              <a:rPr lang="zh-CN" altLang="en-US"/>
              <a:pPr/>
              <a:t>2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9EC837-F5F4-9E2A-A1BD-3CBA08BCF2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8F395C-6FB6-25BA-FE82-2C4E91FCFD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867D4B-51DE-91F6-E5EE-8A67DF13EE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60E69F-C67B-7946-AD2C-872940230BA8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735430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B2C89F-0728-8254-9F83-4339D6F953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365972-EF77-5A5E-2DFB-45E301CBC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EA6250-819D-7E3B-1E9D-75D4D5265A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A077BF-A616-4641-B547-EF5A678DDF82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419505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07411F-FCAC-659A-ECF5-5408393137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17807F-FD02-0FAD-7EE5-604E7CD4B8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3C666F-0D2D-F6AE-038C-7086D0DAC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68CADA-E8F6-FD43-B6D5-E47554937183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952632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49E748-29C2-3F82-BD1C-3F526A7B3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00BDBA-4511-A5D2-7E64-78AF837DD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2AC9DA-4C72-4788-EBCE-AE573D647B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2A125D-0F7A-FD48-B447-FABD392D0D29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269197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846DEF-3C68-DCAA-6DC2-441AD64B3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0CF425-D851-C27B-1BA6-34232E2756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0D759C-D56E-CC5C-12E1-ECF324A85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64A680-3F8C-9346-978D-BB83B45086D6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786346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FF029557-BF9E-C63C-3496-951D16FA7D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4B09BD53-0C58-142C-A922-BF5D61EB2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9D70E5AA-705B-3B4B-9709-7D1E8CB4B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942665-B693-A54E-89D5-587BAB8BADFB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145524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44FF569F-8893-D2F3-A6BA-69B3E11F8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17D6055B-4419-4A5D-A621-62C5AD60D0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6DABD1F2-27F2-54D6-5ED6-59DF42A0F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7AAFB2-4A51-4640-A402-8569A4070AA8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100312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A19C6DD5-9384-83D4-2E9E-739374484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A0B91169-2E66-63B4-AD3A-1BE2717B3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1E5C0974-C658-7E16-6344-579CE4BBA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40BC33-F044-FB4A-8EDE-869EBF39322C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349811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CF0D82B6-A202-3A5C-36EC-8CE32393A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944B92A0-9D7D-8AB7-0753-E12CB7802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14A49E59-A310-E5A0-EA48-8A02B442FA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A3F3B0-3CEF-F04F-80F7-43564A8F2EA7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766151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3352AF19-96CE-95CD-3C15-B9CDED5FB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5B7A4166-C8B0-AC23-B507-9B8677163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65632B82-BF4D-25D8-0055-328A1EEA61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0F0D8C-17AE-F744-A9AE-AF4F1FC14EB3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7676588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zh-CN" altLang="en-US" noProof="0"/>
              <a:t>单击图标添加图片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A42B461-FC38-992D-471D-E5BA25BAA3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B66A9D67-7742-AFF1-3FFC-257437387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1814942-FA4E-127B-FFF6-4FCF9A28DE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FD2AD5-E63F-D04A-998A-7C2E15065F68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149345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EF9A5841-1823-C940-C836-752ACA372302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2CAD1A61-C868-BE9F-A5E0-E4AA7C48D7D5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8002BE-CB1E-B8BC-7786-866A64227CF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6EE36E-5963-5E13-D8E7-79008BE16C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FC7359-AFF4-9C5C-FD0D-593BC45E9F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C0054B9-916F-0347-8F2E-CC960733A99D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.pn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openxmlformats.org/officeDocument/2006/relationships/image" Target="../media/image7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jpeg"/><Relationship Id="rId5" Type="http://schemas.openxmlformats.org/officeDocument/2006/relationships/image" Target="../media/image2.png"/><Relationship Id="rId10" Type="http://schemas.openxmlformats.org/officeDocument/2006/relationships/image" Target="../media/image5.jpeg"/><Relationship Id="rId4" Type="http://schemas.microsoft.com/office/2007/relationships/hdphoto" Target="../media/hdphoto1.wdp"/><Relationship Id="rId9" Type="http://schemas.openxmlformats.org/officeDocument/2006/relationships/image" Target="../media/image4.jpeg"/><Relationship Id="rId14" Type="http://schemas.openxmlformats.org/officeDocument/2006/relationships/image" Target="../media/image9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openxmlformats.org/officeDocument/2006/relationships/image" Target="../media/image11.tiff"/><Relationship Id="rId7" Type="http://schemas.microsoft.com/office/2007/relationships/hdphoto" Target="../media/hdphoto5.wdp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11" Type="http://schemas.microsoft.com/office/2007/relationships/hdphoto" Target="../media/hdphoto7.wdp"/><Relationship Id="rId5" Type="http://schemas.microsoft.com/office/2007/relationships/hdphoto" Target="../media/hdphoto4.wdp"/><Relationship Id="rId10" Type="http://schemas.openxmlformats.org/officeDocument/2006/relationships/image" Target="../media/image3.png"/><Relationship Id="rId4" Type="http://schemas.openxmlformats.org/officeDocument/2006/relationships/image" Target="../media/image12.png"/><Relationship Id="rId9" Type="http://schemas.microsoft.com/office/2007/relationships/hdphoto" Target="../media/hdphoto6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3" Type="http://schemas.openxmlformats.org/officeDocument/2006/relationships/image" Target="../media/image5.jpeg"/><Relationship Id="rId7" Type="http://schemas.microsoft.com/office/2007/relationships/hdphoto" Target="../media/hdphoto8.wdp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tiff"/><Relationship Id="rId4" Type="http://schemas.openxmlformats.org/officeDocument/2006/relationships/image" Target="../media/image6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8.tiff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14">
            <a:extLst>
              <a:ext uri="{FF2B5EF4-FFF2-40B4-BE49-F238E27FC236}">
                <a16:creationId xmlns:a16="http://schemas.microsoft.com/office/drawing/2014/main" id="{B251BB21-0F20-0605-32AB-27200B614A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23792" y="2780928"/>
            <a:ext cx="400047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upporting</a:t>
            </a:r>
            <a:r>
              <a: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orrection</a:t>
            </a:r>
          </a:p>
        </p:txBody>
      </p:sp>
    </p:spTree>
    <p:extLst>
      <p:ext uri="{BB962C8B-B14F-4D97-AF65-F5344CB8AC3E}">
        <p14:creationId xmlns:p14="http://schemas.microsoft.com/office/powerpoint/2010/main" val="15802861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 Box 90">
            <a:extLst>
              <a:ext uri="{FF2B5EF4-FFF2-40B4-BE49-F238E27FC236}">
                <a16:creationId xmlns:a16="http://schemas.microsoft.com/office/drawing/2014/main" id="{2BFDA123-EAB4-BAC5-0956-6B528AB4C3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952" y="5874"/>
            <a:ext cx="305671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 typeface="Arial" panose="020B0604020202020204" pitchFamily="34" charset="0"/>
              <a:buNone/>
            </a:pP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(repeat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times)</a:t>
            </a: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7E0FE55B-D3D5-98AF-AC7F-034E99CEA39A}"/>
              </a:ext>
            </a:extLst>
          </p:cNvPr>
          <p:cNvGrpSpPr/>
          <p:nvPr/>
        </p:nvGrpSpPr>
        <p:grpSpPr>
          <a:xfrm>
            <a:off x="3359696" y="344428"/>
            <a:ext cx="4000472" cy="1906351"/>
            <a:chOff x="3359696" y="344428"/>
            <a:chExt cx="4000472" cy="1906351"/>
          </a:xfrm>
        </p:grpSpPr>
        <p:pic>
          <p:nvPicPr>
            <p:cNvPr id="4099" name="图片 2">
              <a:extLst>
                <a:ext uri="{FF2B5EF4-FFF2-40B4-BE49-F238E27FC236}">
                  <a16:creationId xmlns:a16="http://schemas.microsoft.com/office/drawing/2014/main" id="{21316678-39A0-5D26-6934-C83A5FD6141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15031" y="1301082"/>
              <a:ext cx="2520000" cy="432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101" name="图片 6">
              <a:extLst>
                <a:ext uri="{FF2B5EF4-FFF2-40B4-BE49-F238E27FC236}">
                  <a16:creationId xmlns:a16="http://schemas.microsoft.com/office/drawing/2014/main" id="{92697FAA-298E-31BA-D645-7C13F23B156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15031" y="1818779"/>
              <a:ext cx="2520000" cy="432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2FF5921B-5C56-0344-CE6F-EC997CDD8320}"/>
                </a:ext>
              </a:extLst>
            </p:cNvPr>
            <p:cNvGrpSpPr/>
            <p:nvPr/>
          </p:nvGrpSpPr>
          <p:grpSpPr>
            <a:xfrm>
              <a:off x="3559731" y="814972"/>
              <a:ext cx="912430" cy="1373166"/>
              <a:chOff x="2121105" y="659184"/>
              <a:chExt cx="912430" cy="1373166"/>
            </a:xfrm>
          </p:grpSpPr>
          <p:sp>
            <p:nvSpPr>
              <p:cNvPr id="4110" name="文本框 15">
                <a:extLst>
                  <a:ext uri="{FF2B5EF4-FFF2-40B4-BE49-F238E27FC236}">
                    <a16:creationId xmlns:a16="http://schemas.microsoft.com/office/drawing/2014/main" id="{7CECB355-91B3-D4F0-E9C2-31345965C7A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507429" y="1176490"/>
                <a:ext cx="526106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/>
                <a:r>
                  <a:rPr lang="en-US" altLang="zh-CN" sz="1600">
                    <a:latin typeface="Arial" panose="020B0604020202020204" pitchFamily="34" charset="0"/>
                    <a:cs typeface="Arial" panose="020B0604020202020204" pitchFamily="34" charset="0"/>
                  </a:rPr>
                  <a:t>p38</a:t>
                </a:r>
                <a:endParaRPr lang="zh-CN" alt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11" name="文本框 16">
                <a:extLst>
                  <a:ext uri="{FF2B5EF4-FFF2-40B4-BE49-F238E27FC236}">
                    <a16:creationId xmlns:a16="http://schemas.microsoft.com/office/drawing/2014/main" id="{0E8BE3F1-4AFB-9C9A-F527-88A8429976F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20746" y="659184"/>
                <a:ext cx="708847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/>
                <a:r>
                  <a:rPr lang="en-US" altLang="zh-CN" sz="1600">
                    <a:latin typeface="Arial" panose="020B0604020202020204" pitchFamily="34" charset="0"/>
                    <a:cs typeface="Arial" panose="020B0604020202020204" pitchFamily="34" charset="0"/>
                  </a:rPr>
                  <a:t>p-p38</a:t>
                </a:r>
                <a:endParaRPr lang="zh-CN" alt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12" name="文本框 17">
                <a:extLst>
                  <a:ext uri="{FF2B5EF4-FFF2-40B4-BE49-F238E27FC236}">
                    <a16:creationId xmlns:a16="http://schemas.microsoft.com/office/drawing/2014/main" id="{6A013552-AE68-D479-2CD9-34712891670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121105" y="1693796"/>
                <a:ext cx="912429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/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5" name="Text Box 14">
              <a:extLst>
                <a:ext uri="{FF2B5EF4-FFF2-40B4-BE49-F238E27FC236}">
                  <a16:creationId xmlns:a16="http://schemas.microsoft.com/office/drawing/2014/main" id="{CA7F38C3-EAF5-ABF5-FF0D-17CC80F8D6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59696" y="344428"/>
              <a:ext cx="4000472" cy="338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G-1 (1</a:t>
              </a:r>
              <a:r>
                <a:rPr lang="el-GR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M)      0     5    15   30   45  60 min </a:t>
              </a:r>
            </a:p>
          </p:txBody>
        </p:sp>
        <p:pic>
          <p:nvPicPr>
            <p:cNvPr id="46" name="图片 45">
              <a:extLst>
                <a:ext uri="{FF2B5EF4-FFF2-40B4-BE49-F238E27FC236}">
                  <a16:creationId xmlns:a16="http://schemas.microsoft.com/office/drawing/2014/main" id="{81245DB6-DE05-B581-26D1-D6422EB49043}"/>
                </a:ext>
              </a:extLst>
            </p:cNvPr>
            <p:cNvPicPr>
              <a:picLocks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515031" y="783384"/>
              <a:ext cx="2520000" cy="43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</p:grpSp>
      <p:pic>
        <p:nvPicPr>
          <p:cNvPr id="3" name="图片 2">
            <a:extLst>
              <a:ext uri="{FF2B5EF4-FFF2-40B4-BE49-F238E27FC236}">
                <a16:creationId xmlns:a16="http://schemas.microsoft.com/office/drawing/2014/main" id="{01EF5946-74F8-F75C-7F41-BA1C99A1B99A}"/>
              </a:ext>
            </a:extLst>
          </p:cNvPr>
          <p:cNvPicPr preferRelativeResize="0"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515031" y="3181404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图片 4">
            <a:extLst>
              <a:ext uri="{FF2B5EF4-FFF2-40B4-BE49-F238E27FC236}">
                <a16:creationId xmlns:a16="http://schemas.microsoft.com/office/drawing/2014/main" id="{A12CD459-B0D9-2123-A38F-6C7426C31BE5}"/>
              </a:ext>
            </a:extLst>
          </p:cNvPr>
          <p:cNvPicPr preferRelativeResize="0"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515031" y="2634004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图片 6">
            <a:extLst>
              <a:ext uri="{FF2B5EF4-FFF2-40B4-BE49-F238E27FC236}">
                <a16:creationId xmlns:a16="http://schemas.microsoft.com/office/drawing/2014/main" id="{4C51BA52-CBF4-D373-EAE2-DBD75C62103A}"/>
              </a:ext>
            </a:extLst>
          </p:cNvPr>
          <p:cNvPicPr preferRelativeResize="0"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515031" y="3728804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图片 2">
            <a:extLst>
              <a:ext uri="{FF2B5EF4-FFF2-40B4-BE49-F238E27FC236}">
                <a16:creationId xmlns:a16="http://schemas.microsoft.com/office/drawing/2014/main" id="{8AA41310-E6F7-1F8C-E812-49CADEC34D1A}"/>
              </a:ext>
            </a:extLst>
          </p:cNvPr>
          <p:cNvPicPr preferRelativeResize="0">
            <a:picLocks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509804" y="5219022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图片 4">
            <a:extLst>
              <a:ext uri="{FF2B5EF4-FFF2-40B4-BE49-F238E27FC236}">
                <a16:creationId xmlns:a16="http://schemas.microsoft.com/office/drawing/2014/main" id="{C286C26F-B7E8-5165-A058-3D444F92A9CC}"/>
              </a:ext>
            </a:extLst>
          </p:cNvPr>
          <p:cNvPicPr preferRelativeResize="0">
            <a:picLocks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509804" y="4687304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图片 6">
            <a:extLst>
              <a:ext uri="{FF2B5EF4-FFF2-40B4-BE49-F238E27FC236}">
                <a16:creationId xmlns:a16="http://schemas.microsoft.com/office/drawing/2014/main" id="{62367C16-0D39-49D6-3270-297696E2BF5D}"/>
              </a:ext>
            </a:extLst>
          </p:cNvPr>
          <p:cNvPicPr preferRelativeResize="0">
            <a:picLocks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509804" y="5750740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34" name="组合 33">
            <a:extLst>
              <a:ext uri="{FF2B5EF4-FFF2-40B4-BE49-F238E27FC236}">
                <a16:creationId xmlns:a16="http://schemas.microsoft.com/office/drawing/2014/main" id="{EC35EAC7-A5E8-A946-1E00-F4257E2B6318}"/>
              </a:ext>
            </a:extLst>
          </p:cNvPr>
          <p:cNvGrpSpPr/>
          <p:nvPr/>
        </p:nvGrpSpPr>
        <p:grpSpPr>
          <a:xfrm>
            <a:off x="3559731" y="2754883"/>
            <a:ext cx="912430" cy="1373166"/>
            <a:chOff x="2121105" y="659184"/>
            <a:chExt cx="912430" cy="1373166"/>
          </a:xfrm>
        </p:grpSpPr>
        <p:sp>
          <p:nvSpPr>
            <p:cNvPr id="36" name="文本框 15">
              <a:extLst>
                <a:ext uri="{FF2B5EF4-FFF2-40B4-BE49-F238E27FC236}">
                  <a16:creationId xmlns:a16="http://schemas.microsoft.com/office/drawing/2014/main" id="{FBFECECE-D83A-D0C2-2B4A-71589A4619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07429" y="1176490"/>
              <a:ext cx="52610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16">
              <a:extLst>
                <a:ext uri="{FF2B5EF4-FFF2-40B4-BE49-F238E27FC236}">
                  <a16:creationId xmlns:a16="http://schemas.microsoft.com/office/drawing/2014/main" id="{6F2454F6-AB90-B8C0-5590-13ED5B1548E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20746" y="659184"/>
              <a:ext cx="708847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-p38</a:t>
              </a:r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17">
              <a:extLst>
                <a:ext uri="{FF2B5EF4-FFF2-40B4-BE49-F238E27FC236}">
                  <a16:creationId xmlns:a16="http://schemas.microsoft.com/office/drawing/2014/main" id="{3173EAA0-D56B-6749-380C-F52DDE367C8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21105" y="1693796"/>
              <a:ext cx="912429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C2BA7A25-2FB1-D3EB-6DC8-629D6D3127D4}"/>
              </a:ext>
            </a:extLst>
          </p:cNvPr>
          <p:cNvGrpSpPr/>
          <p:nvPr/>
        </p:nvGrpSpPr>
        <p:grpSpPr>
          <a:xfrm>
            <a:off x="3559731" y="4736916"/>
            <a:ext cx="912430" cy="1373166"/>
            <a:chOff x="2121105" y="659184"/>
            <a:chExt cx="912430" cy="1373166"/>
          </a:xfrm>
        </p:grpSpPr>
        <p:sp>
          <p:nvSpPr>
            <p:cNvPr id="40" name="文本框 15">
              <a:extLst>
                <a:ext uri="{FF2B5EF4-FFF2-40B4-BE49-F238E27FC236}">
                  <a16:creationId xmlns:a16="http://schemas.microsoft.com/office/drawing/2014/main" id="{3DED0B91-8F84-181D-3E3D-AED1F97A03F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07429" y="1176490"/>
              <a:ext cx="52610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16">
              <a:extLst>
                <a:ext uri="{FF2B5EF4-FFF2-40B4-BE49-F238E27FC236}">
                  <a16:creationId xmlns:a16="http://schemas.microsoft.com/office/drawing/2014/main" id="{7438CFD6-DAAA-7F26-793D-3875828B95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20746" y="659184"/>
              <a:ext cx="708847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-p38</a:t>
              </a:r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17">
              <a:extLst>
                <a:ext uri="{FF2B5EF4-FFF2-40B4-BE49-F238E27FC236}">
                  <a16:creationId xmlns:a16="http://schemas.microsoft.com/office/drawing/2014/main" id="{549B9827-3A5B-2A9B-497F-65B0D56179C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21105" y="1693796"/>
              <a:ext cx="912429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3" name="文本框 17">
            <a:extLst>
              <a:ext uri="{FF2B5EF4-FFF2-40B4-BE49-F238E27FC236}">
                <a16:creationId xmlns:a16="http://schemas.microsoft.com/office/drawing/2014/main" id="{B08963F6-2885-8060-225F-528B460D88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14620" y="2250779"/>
            <a:ext cx="10166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epeat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17">
            <a:extLst>
              <a:ext uri="{FF2B5EF4-FFF2-40B4-BE49-F238E27FC236}">
                <a16:creationId xmlns:a16="http://schemas.microsoft.com/office/drawing/2014/main" id="{92BD3949-7007-7BED-586D-626B107CAB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32078" y="4165198"/>
            <a:ext cx="10166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epeat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17">
            <a:extLst>
              <a:ext uri="{FF2B5EF4-FFF2-40B4-BE49-F238E27FC236}">
                <a16:creationId xmlns:a16="http://schemas.microsoft.com/office/drawing/2014/main" id="{BE6C4813-0A12-FB9F-7DAB-60E36CFB85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66718" y="6182740"/>
            <a:ext cx="10166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epeat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48199CC-208D-7347-548B-0B2EFA0430F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39416" y="3796324"/>
            <a:ext cx="3175620" cy="254049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4599D6A-BF6F-6339-A527-23723D4094C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51784" y="3789040"/>
            <a:ext cx="3175620" cy="254049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191E8627-AE76-0DEC-CFCF-2C03FBCC31F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680176" y="3789040"/>
            <a:ext cx="3175620" cy="2540496"/>
          </a:xfrm>
          <a:prstGeom prst="rect">
            <a:avLst/>
          </a:prstGeom>
        </p:spPr>
      </p:pic>
      <p:sp>
        <p:nvSpPr>
          <p:cNvPr id="16" name="文本框 17">
            <a:extLst>
              <a:ext uri="{FF2B5EF4-FFF2-40B4-BE49-F238E27FC236}">
                <a16:creationId xmlns:a16="http://schemas.microsoft.com/office/drawing/2014/main" id="{84444508-73C6-2C16-E187-14567B28AA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31870" y="906251"/>
            <a:ext cx="223811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epeat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2">
            <a:extLst>
              <a:ext uri="{FF2B5EF4-FFF2-40B4-BE49-F238E27FC236}">
                <a16:creationId xmlns:a16="http://schemas.microsoft.com/office/drawing/2014/main" id="{021AE5B9-FEC6-F602-39AF-44C552833CA1}"/>
              </a:ext>
            </a:extLst>
          </p:cNvPr>
          <p:cNvPicPr preferRelativeResize="0">
            <a:picLocks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531870" y="2087777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图片 6">
            <a:extLst>
              <a:ext uri="{FF2B5EF4-FFF2-40B4-BE49-F238E27FC236}">
                <a16:creationId xmlns:a16="http://schemas.microsoft.com/office/drawing/2014/main" id="{40478798-11E1-4D54-2003-699AC0FF9156}"/>
              </a:ext>
            </a:extLst>
          </p:cNvPr>
          <p:cNvPicPr preferRelativeResize="0">
            <a:picLocks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531870" y="2624656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9" name="组合 18">
            <a:extLst>
              <a:ext uri="{FF2B5EF4-FFF2-40B4-BE49-F238E27FC236}">
                <a16:creationId xmlns:a16="http://schemas.microsoft.com/office/drawing/2014/main" id="{698046D5-9EA8-7E56-CEC5-4781DF08B71E}"/>
              </a:ext>
            </a:extLst>
          </p:cNvPr>
          <p:cNvGrpSpPr/>
          <p:nvPr/>
        </p:nvGrpSpPr>
        <p:grpSpPr>
          <a:xfrm>
            <a:off x="3576570" y="1620849"/>
            <a:ext cx="912430" cy="1373166"/>
            <a:chOff x="2121105" y="659184"/>
            <a:chExt cx="912430" cy="1373166"/>
          </a:xfrm>
        </p:grpSpPr>
        <p:sp>
          <p:nvSpPr>
            <p:cNvPr id="20" name="文本框 15">
              <a:extLst>
                <a:ext uri="{FF2B5EF4-FFF2-40B4-BE49-F238E27FC236}">
                  <a16:creationId xmlns:a16="http://schemas.microsoft.com/office/drawing/2014/main" id="{EEAA9D42-F255-F3FA-4699-57C5E175140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07429" y="1176490"/>
              <a:ext cx="52610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16">
              <a:extLst>
                <a:ext uri="{FF2B5EF4-FFF2-40B4-BE49-F238E27FC236}">
                  <a16:creationId xmlns:a16="http://schemas.microsoft.com/office/drawing/2014/main" id="{52B9DCD7-6720-24F6-492F-F0AE915DFC0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20746" y="659184"/>
              <a:ext cx="708847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p-p38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17">
              <a:extLst>
                <a:ext uri="{FF2B5EF4-FFF2-40B4-BE49-F238E27FC236}">
                  <a16:creationId xmlns:a16="http://schemas.microsoft.com/office/drawing/2014/main" id="{066A6152-C556-AB98-3018-A955D46FF5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21105" y="1693796"/>
              <a:ext cx="912429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3" name="图片 22">
            <a:extLst>
              <a:ext uri="{FF2B5EF4-FFF2-40B4-BE49-F238E27FC236}">
                <a16:creationId xmlns:a16="http://schemas.microsoft.com/office/drawing/2014/main" id="{D5305D66-9DAE-0709-130B-1795425DDBAD}"/>
              </a:ext>
            </a:extLst>
          </p:cNvPr>
          <p:cNvPicPr>
            <a:picLocks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31870" y="1589261"/>
            <a:ext cx="2520000" cy="432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24" name="文本框 17">
            <a:extLst>
              <a:ext uri="{FF2B5EF4-FFF2-40B4-BE49-F238E27FC236}">
                <a16:creationId xmlns:a16="http://schemas.microsoft.com/office/drawing/2014/main" id="{DC0D4E81-4F36-3030-E193-9F966BD521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31459" y="3056656"/>
            <a:ext cx="10166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epeat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16">
            <a:extLst>
              <a:ext uri="{FF2B5EF4-FFF2-40B4-BE49-F238E27FC236}">
                <a16:creationId xmlns:a16="http://schemas.microsoft.com/office/drawing/2014/main" id="{7148D375-3CF7-500D-3788-D69AF1DFEB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31504" y="5589240"/>
            <a:ext cx="70884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15">
            <a:extLst>
              <a:ext uri="{FF2B5EF4-FFF2-40B4-BE49-F238E27FC236}">
                <a16:creationId xmlns:a16="http://schemas.microsoft.com/office/drawing/2014/main" id="{C0A3F754-D185-9B52-01CA-789E9B478E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37511" y="5373216"/>
            <a:ext cx="52610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17">
            <a:extLst>
              <a:ext uri="{FF2B5EF4-FFF2-40B4-BE49-F238E27FC236}">
                <a16:creationId xmlns:a16="http://schemas.microsoft.com/office/drawing/2014/main" id="{68E2CAEA-9CC3-A17D-7A08-8305F18074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12224" y="5212370"/>
            <a:ext cx="91242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48894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7">
            <a:extLst>
              <a:ext uri="{FF2B5EF4-FFF2-40B4-BE49-F238E27FC236}">
                <a16:creationId xmlns:a16="http://schemas.microsoft.com/office/drawing/2014/main" id="{E4C2D67B-3A1F-FD37-EF5A-080022610F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31870" y="338514"/>
            <a:ext cx="223811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epeat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A02CDA4A-D46B-DD2A-F102-959F554E6613}"/>
              </a:ext>
            </a:extLst>
          </p:cNvPr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695198" y="1262501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图片 4">
            <a:extLst>
              <a:ext uri="{FF2B5EF4-FFF2-40B4-BE49-F238E27FC236}">
                <a16:creationId xmlns:a16="http://schemas.microsoft.com/office/drawing/2014/main" id="{E28D8059-0A5E-7E6F-C669-DCDB4102B357}"/>
              </a:ext>
            </a:extLst>
          </p:cNvPr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695198" y="746110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图片 6">
            <a:extLst>
              <a:ext uri="{FF2B5EF4-FFF2-40B4-BE49-F238E27FC236}">
                <a16:creationId xmlns:a16="http://schemas.microsoft.com/office/drawing/2014/main" id="{3C2B97A6-8865-5BF3-1448-1058A9DF2BC4}"/>
              </a:ext>
            </a:extLst>
          </p:cNvPr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695198" y="1778892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2" name="组合 11">
            <a:extLst>
              <a:ext uri="{FF2B5EF4-FFF2-40B4-BE49-F238E27FC236}">
                <a16:creationId xmlns:a16="http://schemas.microsoft.com/office/drawing/2014/main" id="{51A2E05E-576F-B364-8936-9D3118984846}"/>
              </a:ext>
            </a:extLst>
          </p:cNvPr>
          <p:cNvGrpSpPr/>
          <p:nvPr/>
        </p:nvGrpSpPr>
        <p:grpSpPr>
          <a:xfrm>
            <a:off x="3729933" y="804971"/>
            <a:ext cx="912430" cy="1373166"/>
            <a:chOff x="2121105" y="659184"/>
            <a:chExt cx="912430" cy="1373166"/>
          </a:xfrm>
        </p:grpSpPr>
        <p:sp>
          <p:nvSpPr>
            <p:cNvPr id="13" name="文本框 15">
              <a:extLst>
                <a:ext uri="{FF2B5EF4-FFF2-40B4-BE49-F238E27FC236}">
                  <a16:creationId xmlns:a16="http://schemas.microsoft.com/office/drawing/2014/main" id="{36B7E111-0C2F-E53A-9FEA-ADAD492E2C3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07429" y="1176490"/>
              <a:ext cx="52610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6">
              <a:extLst>
                <a:ext uri="{FF2B5EF4-FFF2-40B4-BE49-F238E27FC236}">
                  <a16:creationId xmlns:a16="http://schemas.microsoft.com/office/drawing/2014/main" id="{FF5FF35A-7EF7-A484-0621-42C599A4D32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20746" y="659184"/>
              <a:ext cx="708847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-p38</a:t>
              </a:r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7">
              <a:extLst>
                <a:ext uri="{FF2B5EF4-FFF2-40B4-BE49-F238E27FC236}">
                  <a16:creationId xmlns:a16="http://schemas.microsoft.com/office/drawing/2014/main" id="{8650B5F4-DDF2-00ED-3927-DD7EBDAF32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21105" y="1693796"/>
              <a:ext cx="912429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文本框 17">
            <a:extLst>
              <a:ext uri="{FF2B5EF4-FFF2-40B4-BE49-F238E27FC236}">
                <a16:creationId xmlns:a16="http://schemas.microsoft.com/office/drawing/2014/main" id="{8DA39A25-5D57-E959-F1B1-63F22E247D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2280" y="2215286"/>
            <a:ext cx="10166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epeat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C9914010-61EF-1E67-D4B9-A46C4F41CEC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-24680" y="3222719"/>
            <a:ext cx="4191000" cy="33528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09615513-C374-7648-84E4-5DF0341DB203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040733" y="3196634"/>
            <a:ext cx="4191000" cy="3352800"/>
          </a:xfrm>
          <a:prstGeom prst="rect">
            <a:avLst/>
          </a:prstGeom>
        </p:spPr>
      </p:pic>
      <p:sp>
        <p:nvSpPr>
          <p:cNvPr id="19" name="文本框 16">
            <a:extLst>
              <a:ext uri="{FF2B5EF4-FFF2-40B4-BE49-F238E27FC236}">
                <a16:creationId xmlns:a16="http://schemas.microsoft.com/office/drawing/2014/main" id="{06EFFA8D-CD69-A58C-5FE8-A3094CBA39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2573" y="5176099"/>
            <a:ext cx="70884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17">
            <a:extLst>
              <a:ext uri="{FF2B5EF4-FFF2-40B4-BE49-F238E27FC236}">
                <a16:creationId xmlns:a16="http://schemas.microsoft.com/office/drawing/2014/main" id="{09DA4838-5931-E6B1-086C-8477AF9CF9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72296" y="5312166"/>
            <a:ext cx="91242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B8AB5F4-1952-763A-DE00-BD3FF48D04C6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116258" y="3222720"/>
            <a:ext cx="3909424" cy="3224760"/>
          </a:xfrm>
          <a:prstGeom prst="rect">
            <a:avLst/>
          </a:prstGeom>
        </p:spPr>
      </p:pic>
      <p:sp>
        <p:nvSpPr>
          <p:cNvPr id="20" name="文本框 15">
            <a:extLst>
              <a:ext uri="{FF2B5EF4-FFF2-40B4-BE49-F238E27FC236}">
                <a16:creationId xmlns:a16="http://schemas.microsoft.com/office/drawing/2014/main" id="{4827B804-DABF-6DD9-4259-B5B1B69C08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35539" y="5082204"/>
            <a:ext cx="52610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67369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2">
            <a:extLst>
              <a:ext uri="{FF2B5EF4-FFF2-40B4-BE49-F238E27FC236}">
                <a16:creationId xmlns:a16="http://schemas.microsoft.com/office/drawing/2014/main" id="{462CF186-D2AE-63D8-DA90-148F505D89F2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863643" y="1423531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图片 4">
            <a:extLst>
              <a:ext uri="{FF2B5EF4-FFF2-40B4-BE49-F238E27FC236}">
                <a16:creationId xmlns:a16="http://schemas.microsoft.com/office/drawing/2014/main" id="{73D68621-4D33-E634-D5B1-C1C59DB34805}"/>
              </a:ext>
            </a:extLst>
          </p:cNvPr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863643" y="930230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图片 6">
            <a:extLst>
              <a:ext uri="{FF2B5EF4-FFF2-40B4-BE49-F238E27FC236}">
                <a16:creationId xmlns:a16="http://schemas.microsoft.com/office/drawing/2014/main" id="{95AF7FAE-2595-BC49-9FB7-2CB5D8384E79}"/>
              </a:ext>
            </a:extLst>
          </p:cNvPr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863643" y="1916832"/>
            <a:ext cx="2520000" cy="432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1" name="组合 10">
            <a:extLst>
              <a:ext uri="{FF2B5EF4-FFF2-40B4-BE49-F238E27FC236}">
                <a16:creationId xmlns:a16="http://schemas.microsoft.com/office/drawing/2014/main" id="{BD301E5F-5340-0DFF-2EEC-68092CD14B77}"/>
              </a:ext>
            </a:extLst>
          </p:cNvPr>
          <p:cNvGrpSpPr/>
          <p:nvPr/>
        </p:nvGrpSpPr>
        <p:grpSpPr>
          <a:xfrm>
            <a:off x="3880700" y="980728"/>
            <a:ext cx="912430" cy="1373166"/>
            <a:chOff x="2121105" y="659184"/>
            <a:chExt cx="912430" cy="1373166"/>
          </a:xfrm>
        </p:grpSpPr>
        <p:sp>
          <p:nvSpPr>
            <p:cNvPr id="12" name="文本框 15">
              <a:extLst>
                <a:ext uri="{FF2B5EF4-FFF2-40B4-BE49-F238E27FC236}">
                  <a16:creationId xmlns:a16="http://schemas.microsoft.com/office/drawing/2014/main" id="{80DC8705-3AD2-52B0-9596-192D86C446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07429" y="1176490"/>
              <a:ext cx="52610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6">
              <a:extLst>
                <a:ext uri="{FF2B5EF4-FFF2-40B4-BE49-F238E27FC236}">
                  <a16:creationId xmlns:a16="http://schemas.microsoft.com/office/drawing/2014/main" id="{7EFD5B57-BD77-F40C-3163-6A4C4E52B0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20746" y="659184"/>
              <a:ext cx="708847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p-p38</a:t>
              </a:r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7">
              <a:extLst>
                <a:ext uri="{FF2B5EF4-FFF2-40B4-BE49-F238E27FC236}">
                  <a16:creationId xmlns:a16="http://schemas.microsoft.com/office/drawing/2014/main" id="{C4E6DFBA-0256-7A0A-6FAF-426C8021D04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21105" y="1693796"/>
              <a:ext cx="912429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文本框 17">
            <a:extLst>
              <a:ext uri="{FF2B5EF4-FFF2-40B4-BE49-F238E27FC236}">
                <a16:creationId xmlns:a16="http://schemas.microsoft.com/office/drawing/2014/main" id="{249507A6-DDF3-CC96-13BF-2135741D7C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87687" y="2426552"/>
            <a:ext cx="10166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epeat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6361E9BD-1357-E1F5-0FE2-1D54C1ABEDD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0286" y="3163963"/>
            <a:ext cx="3847110" cy="3077688"/>
          </a:xfrm>
          <a:prstGeom prst="rect">
            <a:avLst/>
          </a:prstGeom>
        </p:spPr>
      </p:pic>
      <p:sp>
        <p:nvSpPr>
          <p:cNvPr id="18" name="文本框 16">
            <a:extLst>
              <a:ext uri="{FF2B5EF4-FFF2-40B4-BE49-F238E27FC236}">
                <a16:creationId xmlns:a16="http://schemas.microsoft.com/office/drawing/2014/main" id="{BF63703D-6E9F-9131-FEC1-AF7604F6D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2574" y="5176099"/>
            <a:ext cx="70884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07D2C95-ADA4-E063-66E9-812EEA2E5017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46168" y="3176772"/>
            <a:ext cx="4194048" cy="3364992"/>
          </a:xfrm>
          <a:prstGeom prst="rect">
            <a:avLst/>
          </a:prstGeom>
        </p:spPr>
      </p:pic>
      <p:sp>
        <p:nvSpPr>
          <p:cNvPr id="19" name="文本框 15">
            <a:extLst>
              <a:ext uri="{FF2B5EF4-FFF2-40B4-BE49-F238E27FC236}">
                <a16:creationId xmlns:a16="http://schemas.microsoft.com/office/drawing/2014/main" id="{48473745-F303-75DB-116C-6F0ABB4E4C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37511" y="5373216"/>
            <a:ext cx="52610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76604F3-A8DE-A415-FDA6-66A3BD70BE7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040216" y="3163963"/>
            <a:ext cx="4194048" cy="3364992"/>
          </a:xfrm>
          <a:prstGeom prst="rect">
            <a:avLst/>
          </a:prstGeom>
        </p:spPr>
      </p:pic>
      <p:sp>
        <p:nvSpPr>
          <p:cNvPr id="20" name="文本框 17">
            <a:extLst>
              <a:ext uri="{FF2B5EF4-FFF2-40B4-BE49-F238E27FC236}">
                <a16:creationId xmlns:a16="http://schemas.microsoft.com/office/drawing/2014/main" id="{A864F0CE-0501-7CCF-2DE4-8737CF7C50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72296" y="5312166"/>
            <a:ext cx="91242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13844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693D68C6E0D77543A531ECA1AF65242F" ma:contentTypeVersion="13" ma:contentTypeDescription="Ein neues Dokument erstellen." ma:contentTypeScope="" ma:versionID="8a9224a76c8adab713ef9e4338d8b9d9">
  <xsd:schema xmlns:xsd="http://www.w3.org/2001/XMLSchema" xmlns:xs="http://www.w3.org/2001/XMLSchema" xmlns:p="http://schemas.microsoft.com/office/2006/metadata/properties" xmlns:ns2="4e9c1a30-ac29-4ee3-b6d2-64b56062261e" xmlns:ns3="571cf175-b3ea-4d86-8ad1-bfe8e99f11a0" targetNamespace="http://schemas.microsoft.com/office/2006/metadata/properties" ma:root="true" ma:fieldsID="37d520b899c9b5d9eb7913c26744b8ab" ns2:_="" ns3:_="">
    <xsd:import namespace="4e9c1a30-ac29-4ee3-b6d2-64b56062261e"/>
    <xsd:import namespace="571cf175-b3ea-4d86-8ad1-bfe8e99f11a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e9c1a30-ac29-4ee3-b6d2-64b56062261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description="" ma:hidden="true" ma:indexed="true" ma:internalName="MediaServiceDateTake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7" nillable="true" ma:taxonomy="true" ma:internalName="lcf76f155ced4ddcb4097134ff3c332f" ma:taxonomyFieldName="MediaServiceImageTags" ma:displayName="Bildmarkierungen" ma:readOnly="false" ma:fieldId="{5cf76f15-5ced-4ddc-b409-7134ff3c332f}" ma:taxonomyMulti="true" ma:sspId="4fb58666-e629-4e5a-b780-b8dcc15b318b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description="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71cf175-b3ea-4d86-8ad1-bfe8e99f11a0" elementFormDefault="qualified">
    <xsd:import namespace="http://schemas.microsoft.com/office/2006/documentManagement/types"/>
    <xsd:import namespace="http://schemas.microsoft.com/office/infopath/2007/PartnerControls"/>
    <xsd:element name="TaxCatchAll" ma:index="18" nillable="true" ma:displayName="Taxonomy Catch All Column" ma:hidden="true" ma:list="{ecf77b9a-b311-4a8a-8036-cc163133632b}" ma:internalName="TaxCatchAll" ma:showField="CatchAllData" ma:web="571cf175-b3ea-4d86-8ad1-bfe8e99f11a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571cf175-b3ea-4d86-8ad1-bfe8e99f11a0" xsi:nil="true"/>
    <lcf76f155ced4ddcb4097134ff3c332f xmlns="4e9c1a30-ac29-4ee3-b6d2-64b56062261e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2F0874D8-59F1-400D-8842-BF90627D3C2D}"/>
</file>

<file path=customXml/itemProps2.xml><?xml version="1.0" encoding="utf-8"?>
<ds:datastoreItem xmlns:ds="http://schemas.openxmlformats.org/officeDocument/2006/customXml" ds:itemID="{2194E383-3B3A-4A06-9AA3-8F7D197ABDA7}"/>
</file>

<file path=customXml/itemProps3.xml><?xml version="1.0" encoding="utf-8"?>
<ds:datastoreItem xmlns:ds="http://schemas.openxmlformats.org/officeDocument/2006/customXml" ds:itemID="{A8DE22B7-7ACB-4298-BD39-ED2B2BAC317C}"/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12</TotalTime>
  <Words>75</Words>
  <Application>Microsoft Macintosh PowerPoint</Application>
  <PresentationFormat>宽屏</PresentationFormat>
  <Paragraphs>39</Paragraphs>
  <Slides>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windows</dc:creator>
  <cp:lastModifiedBy>Hongsheng Wang</cp:lastModifiedBy>
  <cp:revision>16</cp:revision>
  <dcterms:created xsi:type="dcterms:W3CDTF">2016-12-02T08:56:59Z</dcterms:created>
  <dcterms:modified xsi:type="dcterms:W3CDTF">2025-07-21T14:43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  <property fmtid="{D5CDD505-2E9C-101B-9397-08002B2CF9AE}" pid="3" name="ContentTypeId">
    <vt:lpwstr>0x010100693D68C6E0D77543A531ECA1AF65242F</vt:lpwstr>
  </property>
</Properties>
</file>